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2"/>
  </p:handoutMasterIdLst>
  <p:sldIdLst>
    <p:sldId id="267" r:id="rId2"/>
    <p:sldId id="278" r:id="rId3"/>
    <p:sldId id="292" r:id="rId4"/>
    <p:sldId id="293" r:id="rId5"/>
    <p:sldId id="287" r:id="rId6"/>
    <p:sldId id="283" r:id="rId7"/>
    <p:sldId id="294" r:id="rId8"/>
    <p:sldId id="295" r:id="rId9"/>
    <p:sldId id="286" r:id="rId10"/>
    <p:sldId id="280" r:id="rId11"/>
  </p:sldIdLst>
  <p:sldSz cx="6858000" cy="9906000" type="A4"/>
  <p:notesSz cx="9926638" cy="679767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50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1FDE36-DDE9-4EDE-BB60-285CC7427A95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CBE4FB-2885-43E7-A6E3-210553F9F18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32441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034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3343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124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151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7249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2282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108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8040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3638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6286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1289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E4219-5E2C-461E-82D8-3A992A4D1FDD}" type="datetimeFigureOut">
              <a:rPr lang="fr-FR" smtClean="0"/>
              <a:t>0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5B245-5ACF-4C87-AFAB-585637F1AF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518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ZoneTexte 57"/>
          <p:cNvSpPr txBox="1"/>
          <p:nvPr/>
        </p:nvSpPr>
        <p:spPr>
          <a:xfrm>
            <a:off x="-1" y="-4444"/>
            <a:ext cx="2562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1</a:t>
            </a:r>
            <a:endParaRPr lang="fr-FR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286"/>
            <a:ext cx="6851904" cy="9759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4903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1" y="39063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</a:t>
            </a:r>
            <a:r>
              <a:rPr lang="fr-FR" dirty="0"/>
              <a:t>Figure </a:t>
            </a:r>
            <a:r>
              <a:rPr lang="fr-FR" dirty="0" smtClean="0"/>
              <a:t>9</a:t>
            </a:r>
            <a:endParaRPr lang="fr-FR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208" y="1405128"/>
            <a:ext cx="6577584" cy="7095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3355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-37202" y="322337"/>
            <a:ext cx="2623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2</a:t>
            </a:r>
            <a:endParaRPr lang="fr-FR" dirty="0"/>
          </a:p>
        </p:txBody>
      </p:sp>
      <p:sp>
        <p:nvSpPr>
          <p:cNvPr id="52" name="AutoShape 4"/>
          <p:cNvSpPr>
            <a:spLocks noChangeAspect="1" noChangeArrowheads="1" noTextEdit="1"/>
          </p:cNvSpPr>
          <p:nvPr/>
        </p:nvSpPr>
        <p:spPr bwMode="auto">
          <a:xfrm>
            <a:off x="172937" y="7334427"/>
            <a:ext cx="1819275" cy="3054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937" y="1006963"/>
            <a:ext cx="4614672" cy="3608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1535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ZoneTexte 53"/>
          <p:cNvSpPr txBox="1"/>
          <p:nvPr/>
        </p:nvSpPr>
        <p:spPr>
          <a:xfrm>
            <a:off x="0" y="0"/>
            <a:ext cx="255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</a:t>
            </a:r>
            <a:r>
              <a:rPr lang="fr-FR" dirty="0"/>
              <a:t>Figure </a:t>
            </a:r>
            <a:r>
              <a:rPr lang="fr-FR" dirty="0" smtClean="0"/>
              <a:t>3A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81125"/>
            <a:ext cx="6858000" cy="7143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2730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ZoneTexte 22"/>
          <p:cNvSpPr txBox="1"/>
          <p:nvPr/>
        </p:nvSpPr>
        <p:spPr>
          <a:xfrm>
            <a:off x="0" y="1257"/>
            <a:ext cx="2543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</a:t>
            </a:r>
            <a:r>
              <a:rPr lang="fr-FR" dirty="0"/>
              <a:t>Figure </a:t>
            </a:r>
            <a:r>
              <a:rPr lang="fr-FR" dirty="0" smtClean="0"/>
              <a:t>3B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7955"/>
            <a:ext cx="6858000" cy="7150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292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ZoneTexte 60"/>
          <p:cNvSpPr txBox="1"/>
          <p:nvPr/>
        </p:nvSpPr>
        <p:spPr>
          <a:xfrm>
            <a:off x="0" y="0"/>
            <a:ext cx="2490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4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6338"/>
            <a:ext cx="6858000" cy="7873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851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-14673" y="3782843"/>
            <a:ext cx="2457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6</a:t>
            </a:r>
            <a:endParaRPr lang="fr-FR" dirty="0"/>
          </a:p>
        </p:txBody>
      </p:sp>
      <p:sp>
        <p:nvSpPr>
          <p:cNvPr id="306" name="ZoneTexte 305"/>
          <p:cNvSpPr txBox="1"/>
          <p:nvPr/>
        </p:nvSpPr>
        <p:spPr>
          <a:xfrm>
            <a:off x="-23158" y="-18395"/>
            <a:ext cx="2561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5</a:t>
            </a:r>
            <a:endParaRPr lang="fr-FR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5859"/>
            <a:ext cx="2773680" cy="268224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46" y="4449117"/>
            <a:ext cx="5754624" cy="1609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3332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-23159" y="-18395"/>
            <a:ext cx="2682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7A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37376"/>
            <a:ext cx="6858000" cy="7831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5710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-23158" y="-18395"/>
            <a:ext cx="2778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7B</a:t>
            </a:r>
            <a:endParaRPr lang="fr-FR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45739"/>
            <a:ext cx="6858000" cy="7014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048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ZoneTexte 44"/>
          <p:cNvSpPr txBox="1"/>
          <p:nvPr/>
        </p:nvSpPr>
        <p:spPr>
          <a:xfrm>
            <a:off x="-9819" y="11487"/>
            <a:ext cx="24281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8</a:t>
            </a:r>
            <a:endParaRPr lang="fr-FR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661" y="779005"/>
            <a:ext cx="3681984" cy="3054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09032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7</TotalTime>
  <Words>33</Words>
  <Application>Microsoft Office PowerPoint</Application>
  <PresentationFormat>Format A4 (210 x 297 mm)</PresentationFormat>
  <Paragraphs>11</Paragraphs>
  <Slides>1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nili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 Feuillard</dc:creator>
  <cp:lastModifiedBy>Christelle Vincent Fabert</cp:lastModifiedBy>
  <cp:revision>213</cp:revision>
  <cp:lastPrinted>2020-12-11T11:12:03Z</cp:lastPrinted>
  <dcterms:created xsi:type="dcterms:W3CDTF">2020-11-20T09:30:18Z</dcterms:created>
  <dcterms:modified xsi:type="dcterms:W3CDTF">2021-04-02T08:40:34Z</dcterms:modified>
</cp:coreProperties>
</file>